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63" r:id="rId3"/>
    <p:sldId id="265" r:id="rId4"/>
    <p:sldId id="264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8F3FF"/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84" y="1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7/10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642265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587407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72820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10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10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10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10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10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10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10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10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10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10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10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7/10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45711" y="5639867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52320" y="5120024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ackenzie et al (2023) Diabetologia DOI 10.1007/s00125-021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3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8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Data-driven tools can include simple calculators, rule-based approaches and AI-driven approach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DD3ED39-66C3-5E75-C563-0F293437110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44438" y="1234234"/>
            <a:ext cx="7071148" cy="3942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45711" y="5639867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An overview of AI and its subcomponents, including machine learning and deep learni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721ED17-3C7F-B470-A9EE-FE2DF43E4BB9}"/>
              </a:ext>
            </a:extLst>
          </p:cNvPr>
          <p:cNvSpPr txBox="1"/>
          <p:nvPr/>
        </p:nvSpPr>
        <p:spPr>
          <a:xfrm>
            <a:off x="1284991" y="4830583"/>
            <a:ext cx="6574018" cy="289441"/>
          </a:xfrm>
          <a:prstGeom prst="roundRect">
            <a:avLst/>
          </a:prstGeom>
          <a:solidFill>
            <a:schemeClr val="bg1">
              <a:lumMod val="95000"/>
            </a:schemeClr>
          </a:solidFill>
        </p:spPr>
        <p:txBody>
          <a:bodyPr wrap="square" rtlCol="0">
            <a:spAutoFit/>
          </a:bodyPr>
          <a:lstStyle/>
          <a:p>
            <a:r>
              <a:rPr lang="en-GB" sz="11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GB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eature refers to an individual and measurable characteristic of data and is typically numerical or categorical</a:t>
            </a:r>
            <a:endParaRPr lang="en-GB" sz="11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FB45D37-78E3-36AB-8394-86E703CADFA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856"/>
          <a:stretch/>
        </p:blipFill>
        <p:spPr>
          <a:xfrm>
            <a:off x="777184" y="1147039"/>
            <a:ext cx="7589632" cy="348890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4DE7C983-E5B7-1A33-3065-5ACBF00C7554}"/>
              </a:ext>
            </a:extLst>
          </p:cNvPr>
          <p:cNvSpPr txBox="1"/>
          <p:nvPr/>
        </p:nvSpPr>
        <p:spPr>
          <a:xfrm>
            <a:off x="352320" y="5120024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ackenzie et al (2023) Diabetologia DOI 10.1007/s00125-021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3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8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1188195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45711" y="5639867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An overview of multisource data inputs, analysis techniques and potential clinically relevant and actionable outputs relevant to diabetes car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A243CA6-9A0C-4D49-61DF-311549296FA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5001" y="1257199"/>
            <a:ext cx="7510022" cy="403244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A2ED729-4F24-FFD4-DBF6-04AFE48BF266}"/>
              </a:ext>
            </a:extLst>
          </p:cNvPr>
          <p:cNvSpPr txBox="1"/>
          <p:nvPr/>
        </p:nvSpPr>
        <p:spPr>
          <a:xfrm>
            <a:off x="352320" y="5120024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ackenzie et al (2023) Diabetologia DOI 10.1007/s00125-021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3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8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0189476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45711" y="5639867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Why is clinician decision support necessary?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73A2973-DFA1-A211-D35C-954849661B7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9592" y="1050569"/>
            <a:ext cx="7560840" cy="416870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7BEF240-906C-173B-3881-F447199C52F5}"/>
              </a:ext>
            </a:extLst>
          </p:cNvPr>
          <p:cNvSpPr txBox="1"/>
          <p:nvPr/>
        </p:nvSpPr>
        <p:spPr>
          <a:xfrm>
            <a:off x="352320" y="5120024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ackenzie et al (2023) Diabetologia DOI 10.1007/s00125-021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3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8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9758458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4</Words>
  <Application>Microsoft Office PowerPoint</Application>
  <PresentationFormat>On-screen Show (4:3)</PresentationFormat>
  <Paragraphs>25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5</cp:revision>
  <dcterms:created xsi:type="dcterms:W3CDTF">2016-06-15T12:53:43Z</dcterms:created>
  <dcterms:modified xsi:type="dcterms:W3CDTF">2023-10-27T15:20:44Z</dcterms:modified>
</cp:coreProperties>
</file>